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98" r:id="rId2"/>
    <p:sldId id="396" r:id="rId3"/>
    <p:sldId id="39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5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A42C6E-00F0-4000-A9F2-1D486C8CD1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1C712D-D4EF-A301-2324-65DFE166F3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D0D94-1CF0-2D03-E43B-19961D514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7ACFF8-4EE7-8BCE-429C-1B1CB5E93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A56F0-129A-CDD5-7DCA-672F763FB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094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D78CE-22D6-3CEF-1B57-38E7F58F5A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9B9591-7576-A9A7-931D-BFB86BF408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C7B56A-9EAC-0D24-A5D5-29644CCCA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3052D6-F264-E667-5DE2-3DCE0ADC0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234D70-DC64-D8E5-103B-DC795E08F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738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8576FB-7E2C-738F-F373-10D6B2F679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318559-2A3A-8660-169D-274EE60653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AEFB9E-8770-626C-88A8-2A1BA89C5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F45E95-0E21-D1BD-ED02-726305766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4D63CF-815D-8AAE-0B64-EF77CBEA0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90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49E09-5B0A-FFE4-0446-0A24C71643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353F95-658D-465D-215F-CF6C2C2D04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A02682-1D8B-8A5C-0E92-19A39DCF8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B16BE1-B23F-AD1B-82BA-E353ADD10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6EB862-08EB-6595-496D-72E325EFD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933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3A74DB-965A-92F3-27BD-EEBF0016CC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9DA06F-EEFA-4D0B-ED40-C7CA6B1B2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CB76E9-22D0-DE89-3FB3-8285D0ABB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1F67B0-EE66-29C3-6D75-E741F7E52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F5C505-0E15-B8AC-339E-A3D9CD953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953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D7CA69-87F4-E876-9EB2-16329DB243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BF8752-88D9-62FC-41FB-5C4B230CD7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E8571D-7106-00A3-3C92-26CDF44CB2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C81842-E34E-819B-D582-48F672B26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23BC9E-DE56-6081-D83B-FBC8C80E7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9028C8-4DE4-C096-9B84-822BB0CB7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406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953B03-A1B3-7930-A826-7F5AA777FC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A47EBA-07E9-6255-07D3-0A71EEFA19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8D87D8-2CA3-C546-1652-59A9A88862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1ED85E-D168-0525-0698-A70BE93FC4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94930A-E6BF-29AD-6D5A-417ADDB18D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1656D7-2881-0E7A-D32C-2F3565596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DA2B1B-7375-329D-B674-F0DB37BA3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B9C363-65D4-0AAD-F5E0-A081E2468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32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16CA87-DCFF-E5D2-CBA3-1873EB1AA3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D4DF43-D8AC-94E3-3F8E-B6BA5BBF2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3FC856-B862-AF8C-E540-F2ED90F5A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C43711-9198-A333-8021-B6EC1B5EA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84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416C8C-0936-CA01-BECB-C9AAC7EC8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30C456-EE40-CBC5-B403-4D0A3ED26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D8232-DCBB-0624-3CB1-EC126C2FA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519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1750C7-0444-5609-F85F-01333C4C9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FF5C49-3985-4F76-485A-BB98028A6A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FEFB8C-F337-26FD-8E1C-9366A259D1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3D480D-0D37-826F-10B5-DB021009C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2B9B50-9107-D6E9-C524-F0EB20459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C082F7-0C69-B8B0-A3F1-E040AAC78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572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20B4C3-0CFF-1761-7672-04E778798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F46A4B-9C97-36AE-1A80-B460BD1536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BFA4A0-E34A-FAFA-5FDC-730342C5E4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A8E411-0569-D830-738C-BE826CD82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1B99F9-EA80-43F0-11D3-1682D666C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F10AB2-F044-7E6B-6E00-6DB51AA42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708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712C4B-FC42-864B-6DF0-B059286F30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944C66-D21F-0754-DE5A-A7764186D4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9F681A-E29B-0B14-2EF9-0E84D6F969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EDE78-5EC8-4FE8-956B-9DA9F2963CB1}" type="datetimeFigureOut">
              <a:rPr lang="en-US" smtClean="0"/>
              <a:t>7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C949AE-5983-4D79-FB67-9E6B4AF657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AF302B-4E69-9F98-8696-5D9A6FE3DD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F7E08-6385-4BA1-80B8-E0155D9825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308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726B8A2-4A66-2732-195F-78BCD5909B37}"/>
              </a:ext>
            </a:extLst>
          </p:cNvPr>
          <p:cNvSpPr txBox="1"/>
          <p:nvPr/>
        </p:nvSpPr>
        <p:spPr>
          <a:xfrm>
            <a:off x="700088" y="1450182"/>
            <a:ext cx="11265693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to </a:t>
            </a:r>
          </a:p>
          <a:p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‘</a:t>
            </a:r>
            <a:r>
              <a:rPr lang="en-US" sz="2400" u="sng" dirty="0">
                <a:latin typeface="Arial" panose="020B0604020202020204" pitchFamily="34" charset="0"/>
                <a:cs typeface="Arial" panose="020B0604020202020204" pitchFamily="34" charset="0"/>
              </a:rPr>
              <a:t>Micromagnetic Insights on In-Plane Magnetization Rotation and Propagation of Magnetization Waves in Nanowires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</a:p>
          <a:p>
            <a:pPr algn="ctr"/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bir Shadman, Jian-Gang (Jimmy) Zhu</a:t>
            </a:r>
          </a:p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jzhu@ece.cmu.edu</a:t>
            </a:r>
          </a:p>
        </p:txBody>
      </p:sp>
    </p:spTree>
    <p:extLst>
      <p:ext uri="{BB962C8B-B14F-4D97-AF65-F5344CB8AC3E}">
        <p14:creationId xmlns:p14="http://schemas.microsoft.com/office/powerpoint/2010/main" val="3169567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5033" y="216982"/>
            <a:ext cx="11641931" cy="685848"/>
          </a:xfrm>
        </p:spPr>
        <p:txBody>
          <a:bodyPr>
            <a:no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Video file of Wave propagation and corresponding precession frequency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8A7370E-AA25-1242-2574-E8C6DD0211BF}"/>
              </a:ext>
            </a:extLst>
          </p:cNvPr>
          <p:cNvSpPr/>
          <p:nvPr/>
        </p:nvSpPr>
        <p:spPr>
          <a:xfrm>
            <a:off x="1703540" y="1150280"/>
            <a:ext cx="389722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urce frequency at 1 GHz</a:t>
            </a:r>
          </a:p>
        </p:txBody>
      </p:sp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7CB7D11A-F714-5558-5171-C83FE465CC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1045" y="1859395"/>
            <a:ext cx="7642595" cy="1263494"/>
          </a:xfrm>
          <a:prstGeom prst="rect">
            <a:avLst/>
          </a:prstGeom>
        </p:spPr>
      </p:pic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40F2C4A3-953B-6B4E-D62A-B6C9681250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4603" y="3188260"/>
            <a:ext cx="8102581" cy="3669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8020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B5C70-8E2F-F61A-29F0-6DBFD22905DF}"/>
              </a:ext>
            </a:extLst>
          </p:cNvPr>
          <p:cNvSpPr txBox="1">
            <a:spLocks/>
          </p:cNvSpPr>
          <p:nvPr/>
        </p:nvSpPr>
        <p:spPr>
          <a:xfrm>
            <a:off x="275033" y="216982"/>
            <a:ext cx="11641931" cy="6858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ure - S1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CA1E5C5-9E69-2877-90CE-DDFF619C5ADA}"/>
              </a:ext>
            </a:extLst>
          </p:cNvPr>
          <p:cNvGrpSpPr/>
          <p:nvPr/>
        </p:nvGrpSpPr>
        <p:grpSpPr>
          <a:xfrm>
            <a:off x="1151441" y="795674"/>
            <a:ext cx="9324747" cy="3978300"/>
            <a:chOff x="1165727" y="1222350"/>
            <a:chExt cx="9324747" cy="39783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F97EC12-5D6A-DDE6-7338-F26BD73434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714"/>
            <a:stretch/>
          </p:blipFill>
          <p:spPr>
            <a:xfrm>
              <a:off x="1165727" y="1222350"/>
              <a:ext cx="9324747" cy="3978300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4AE0911C-C4F5-D6B4-CE1D-F2118C14A792}"/>
                    </a:ext>
                  </a:extLst>
                </p:cNvPr>
                <p:cNvSpPr txBox="1"/>
                <p:nvPr/>
              </p:nvSpPr>
              <p:spPr>
                <a:xfrm>
                  <a:off x="5464968" y="4751458"/>
                  <a:ext cx="240056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b="0" i="1" dirty="0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  <m:t>𝑓</m:t>
                        </m:r>
                      </m:oMath>
                    </m:oMathPara>
                  </a14:m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4AE0911C-C4F5-D6B4-CE1D-F2118C14A79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464968" y="4751458"/>
                  <a:ext cx="240056" cy="369332"/>
                </a:xfrm>
                <a:prstGeom prst="rect">
                  <a:avLst/>
                </a:prstGeom>
                <a:blipFill>
                  <a:blip r:embed="rId3"/>
                  <a:stretch>
                    <a:fillRect l="-7500" r="-35000" b="-14754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C0D1664-F188-D44E-9A10-620035AE54E8}"/>
                    </a:ext>
                  </a:extLst>
                </p:cNvPr>
                <p:cNvSpPr txBox="1"/>
                <p:nvPr/>
              </p:nvSpPr>
              <p:spPr>
                <a:xfrm rot="16200000">
                  <a:off x="362073" y="2947868"/>
                  <a:ext cx="2678906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14:m>
                    <m:oMath xmlns:m="http://schemas.openxmlformats.org/officeDocument/2006/math">
                      <m:r>
                        <a:rPr lang="en-US" b="0" i="1" dirty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𝜆</m:t>
                      </m:r>
                    </m:oMath>
                  </a14:m>
                  <a:r>
                    <a:rPr lang="en-US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(nm)</a:t>
                  </a:r>
                </a:p>
              </p:txBody>
            </p:sp>
          </mc:Choice>
          <mc:Fallback xmlns=""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C0D1664-F188-D44E-9A10-620035AE54E8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>
                  <a:off x="362073" y="2947868"/>
                  <a:ext cx="2678906" cy="369332"/>
                </a:xfrm>
                <a:prstGeom prst="rect">
                  <a:avLst/>
                </a:prstGeom>
                <a:blipFill>
                  <a:blip r:embed="rId4"/>
                  <a:stretch>
                    <a:fillRect l="-8197" r="-2459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19B1C92-28D0-9028-19BB-DF140FD22F4F}"/>
                  </a:ext>
                </a:extLst>
              </p:cNvPr>
              <p:cNvSpPr txBox="1"/>
              <p:nvPr/>
            </p:nvSpPr>
            <p:spPr>
              <a:xfrm>
                <a:off x="519186" y="5041405"/>
                <a:ext cx="11275146" cy="10209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lnSpc>
                    <a:spcPct val="115000"/>
                  </a:lnSpc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Fig. S1. Steady state wavelength, </a:t>
                </a:r>
                <a14:m>
                  <m:oMath xmlns:m="http://schemas.openxmlformats.org/officeDocument/2006/math">
                    <m:r>
                      <a:rPr lang="en-US" b="0" i="1" smtClean="0">
                        <a:effectLst/>
                        <a:latin typeface="Cambria Math" panose="020405030504060302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m:t>𝜆</m:t>
                    </m:r>
                  </m:oMath>
                </a14:m>
                <a:r>
                  <a:rPr lang="en-US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 versus the spin precession frequency, </a:t>
                </a:r>
                <a14:m>
                  <m:oMath xmlns:m="http://schemas.openxmlformats.org/officeDocument/2006/math">
                    <m:r>
                      <a:rPr lang="en-US" b="0" i="1" smtClean="0">
                        <a:effectLst/>
                        <a:latin typeface="Cambria Math" panose="020405030504060302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m:t>𝑓</m:t>
                    </m:r>
                  </m:oMath>
                </a14:m>
                <a:r>
                  <a:rPr lang="en-US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which is determined by the input sourc</a:t>
                </a:r>
                <a:r>
                  <a:rPr lang="en-US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 spin rotation and same all along the wire. The lowest </a:t>
                </a:r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m:t>𝜆</m:t>
                    </m:r>
                  </m:oMath>
                </a14:m>
                <a:r>
                  <a:rPr lang="en-US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for each frequency occurs at the source end while the maximum is at the other end.</a:t>
                </a:r>
              </a:p>
            </p:txBody>
          </p:sp>
        </mc:Choice>
        <mc:Fallback xmlns="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19B1C92-28D0-9028-19BB-DF140FD22F4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19186" y="5041405"/>
                <a:ext cx="11275146" cy="1020921"/>
              </a:xfrm>
              <a:prstGeom prst="rect">
                <a:avLst/>
              </a:prstGeom>
              <a:blipFill>
                <a:blip r:embed="rId5"/>
                <a:stretch>
                  <a:fillRect l="-432" t="-1198" r="-757" b="-898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373569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07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ambria Math</vt:lpstr>
      <vt:lpstr>Office Theme</vt:lpstr>
      <vt:lpstr>PowerPoint Presentation</vt:lpstr>
      <vt:lpstr>Video file of Wave propagation and corresponding precession frequency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ave propagation and corresponding Precession frequency</dc:title>
  <dc:creator>Abir Shadman</dc:creator>
  <cp:lastModifiedBy>Abir Shadman</cp:lastModifiedBy>
  <cp:revision>6</cp:revision>
  <dcterms:created xsi:type="dcterms:W3CDTF">2023-07-24T15:16:24Z</dcterms:created>
  <dcterms:modified xsi:type="dcterms:W3CDTF">2023-07-24T17:56:48Z</dcterms:modified>
</cp:coreProperties>
</file>